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0" d="100"/>
          <a:sy n="120" d="100"/>
        </p:scale>
        <p:origin x="208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7F6307-75E8-0002-E16C-6927BE59E8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65AEC84-560E-37C1-5CAC-E0C00428737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DEF20B6-2FDD-90D6-D7AE-816D15D80E6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6EA424-563E-BDFB-8C8F-F24CEB7151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C2EC65-2FF9-5C70-8924-E8FA58A9D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2394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669287-9DDA-8042-34BA-1E6A7A2F3E2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3E07B3-C02A-E7E2-6534-CA83CC1CDC4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0F1999-69E4-C406-494A-8F1AE22F64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919923E-EC1F-96FF-0F2A-6D67811D9AB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010E45-50F3-B8E0-F1EB-AFD013DE9C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4587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E84D745-8339-8993-0D3E-5534BDB863A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78182D2-1CEE-6A8D-D039-6AAB9868D05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3026A0-47B8-4804-4EB8-AB569AB3C1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2691F8-D192-E26E-3DF0-6D5EBF3F3E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09B2967-E0D3-0D76-6792-E4169CDC49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70516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3CC4BD-02B4-6886-DE59-409B33305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C8B1FD0-B1F2-B8B8-0504-745312B53DB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389C9C9-8760-1F58-D461-150E76D028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DBEBD6-BA7C-2DC7-685C-E3747098F9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DD9256-AA83-AA5E-0507-D211727CC9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1723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B92801-C98D-660C-21D3-66B70A357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F1A3546-4A12-AE32-920B-3DEC440C7C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9260087-D9CC-FB40-7E98-E27A26E753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A36EE5F-4DD6-EFFE-9467-AC7F1E87B5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1BD06A-DE2D-0902-0281-FCC05C9731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64935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B81F61-328D-D80D-0606-D281B86E5CD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712C1A-E307-076B-959B-D3490FC0B9C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C71945-F9C4-8774-F31C-2808C065075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324082D-E994-B2EE-8437-469FD463EE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D1BD3CE-11FA-D5D4-D093-B4F21ABBE4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54051F3-48B5-58F0-7EA0-8FDDE9BF8A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90465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ADDB1BE-877E-C7B5-89DD-FBC4AF3FDE0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1D7571B-E941-85D7-C992-E9E17073E22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2FDC5-78B5-4E10-C476-C909E654D6E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AA8C39A-6724-9361-1063-CACB7C9E0B1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418297BC-AB84-C163-469A-052F0C7181E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E015AC44-A5FF-BEC5-D866-23FC181966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0D5912A-73CC-65EE-E8B4-052195B2CDF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D504BD5-E60C-1161-45C6-9778C16EF9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24611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96533A-C56F-FEE7-AB8C-CA432392C6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33CBAE66-4FAF-6E39-E0A3-FEBF65905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801DA1-EB54-BD90-0EE1-8F2F04EF98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9D0672A-EE98-5E9E-A079-64471A8D2E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142087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FC84DE19-D001-8ED9-8ADD-20009E08D8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D2FDD0E-9170-A446-AE98-E743E81F4B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C05B2DB-C6D3-AA2F-D806-B7293C8CC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60166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207A2FE-1AA5-C855-F401-BD67D79751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C496D1-D89E-5060-B2CF-EF90E2E35F8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D2BB9E-537F-965E-E978-2C9D1C2BAEB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B35905A-EDEB-BAFF-C3A8-368597D4E1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E8ADD6-603E-186F-4ACC-39772F6F6A3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556D220-87C1-9BD2-B033-A21EE46CD7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09713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4ABA49-1C23-1995-7EF8-353D6D80FE1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28237B-E747-8A7A-73B7-ED61A5AA9ED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F7714E-7117-B556-D9E7-76091E12709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218F057-ABC4-4D02-20DF-B98A83A514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1BEE9F3-88A2-A76B-B5E3-1B4A6C29080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2218F5-F3B9-7119-E963-BD9D75AACA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2194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F8A9402-123C-547A-7F99-B85843CAB8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7CB1DB1-B521-1488-6EC3-BFF39EEDDD4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CE6A3D-7CEF-2D9E-FB6D-4858909E3E5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7C40515-89F9-4E47-8F96-C9D5871E8FD3}" type="datetimeFigureOut">
              <a:rPr lang="en-US" smtClean="0"/>
              <a:t>2/19/26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EB2762-CD83-9DDF-F607-C1692C62F7F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988BC5-CA2A-9823-BAF3-FEE7DD21E5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29BD25A-6A73-9D45-AF7D-D0F3BD3CBE2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30655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2FC7ECF7-3F76-DC28-1844-6D12654D45E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389722" y="-1"/>
            <a:ext cx="5410783" cy="6119337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EA19E192-553B-580F-4111-472687A85DE2}"/>
              </a:ext>
            </a:extLst>
          </p:cNvPr>
          <p:cNvSpPr txBox="1"/>
          <p:nvPr/>
        </p:nvSpPr>
        <p:spPr>
          <a:xfrm>
            <a:off x="-1772" y="6119336"/>
            <a:ext cx="1219377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 algn="just" fontAlgn="base">
              <a:buNone/>
            </a:pP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Figure S7: Flow plots for hFlex3a2_v2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b surface stains and </a:t>
            </a:r>
            <a:r>
              <a:rPr lang="en-US" sz="1400" b="1" i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2a percent positive. (A)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Histograms showing surface staining of all hFlex3a2_v2 variants at 4 concentrations against </a:t>
            </a:r>
            <a:r>
              <a:rPr lang="en-US" sz="1400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3b.</a:t>
            </a:r>
            <a:r>
              <a:rPr lang="en-US" sz="1400" b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This experiment is the result of three biological replicates. (B) Percent of </a:t>
            </a:r>
            <a:r>
              <a:rPr lang="en-US" sz="1400" i="1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S. flexneri </a:t>
            </a:r>
            <a:r>
              <a:rPr lang="en-US" sz="1400" dirty="0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2a positive for staining with hFlex3a2_v2 variants at 1000 </a:t>
            </a:r>
            <a:r>
              <a:rPr lang="en-US" sz="1400" dirty="0" err="1">
                <a:effectLst/>
                <a:latin typeface="Arial" panose="020B0604020202020204" pitchFamily="34" charset="0"/>
                <a:ea typeface="Yu Gothic Light" panose="020B0300000000000000" pitchFamily="34" charset="-128"/>
              </a:rPr>
              <a:t>nM.</a:t>
            </a:r>
            <a:endParaRPr lang="en-US" sz="14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1892898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6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Hayden Schmidt</dc:creator>
  <cp:lastModifiedBy>Hayden Schmidt</cp:lastModifiedBy>
  <cp:revision>1</cp:revision>
  <dcterms:created xsi:type="dcterms:W3CDTF">2026-02-19T23:46:42Z</dcterms:created>
  <dcterms:modified xsi:type="dcterms:W3CDTF">2026-02-19T23:46:56Z</dcterms:modified>
</cp:coreProperties>
</file>